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38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735612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1645604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3184115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1072022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1115005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3069833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809781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2148340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4113186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3074055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1995380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01727-6BE2-4DE0-B5B5-E0BCAA1AB35D}" type="datetimeFigureOut">
              <a:rPr lang="sv-FI" smtClean="0"/>
              <a:t>27-01-2021</a:t>
            </a:fld>
            <a:endParaRPr lang="sv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B140F-AEA5-4C13-909F-5D7BDC5AFDAA}" type="slidenum">
              <a:rPr lang="sv-FI" smtClean="0"/>
              <a:t>‹#›</a:t>
            </a:fld>
            <a:endParaRPr lang="sv-FI"/>
          </a:p>
        </p:txBody>
      </p:sp>
    </p:spTree>
    <p:extLst>
      <p:ext uri="{BB962C8B-B14F-4D97-AF65-F5344CB8AC3E}">
        <p14:creationId xmlns:p14="http://schemas.microsoft.com/office/powerpoint/2010/main" val="2728421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/>
          <p:cNvSpPr txBox="1">
            <a:spLocks noChangeArrowheads="1"/>
          </p:cNvSpPr>
          <p:nvPr/>
        </p:nvSpPr>
        <p:spPr bwMode="auto">
          <a:xfrm>
            <a:off x="2372558" y="1406758"/>
            <a:ext cx="1914525" cy="93442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32080" tIns="66040" rIns="132080" bIns="66040" numCol="1" anchor="t" anchorCtr="0" compatLnSpc="1">
            <a:prstTxWarp prst="textNoShape">
              <a:avLst/>
            </a:prstTxWarp>
          </a:bodyPr>
          <a:lstStyle/>
          <a:p>
            <a:pPr algn="ctr" defTabSz="132075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sv-FI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NDOMIZATION</a:t>
            </a:r>
            <a:br>
              <a:rPr lang="en-US" altLang="sv-FI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ools, n=56</a:t>
            </a:r>
            <a:b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asses, n=210</a:t>
            </a:r>
            <a:b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3519</a:t>
            </a:r>
            <a:endParaRPr lang="en-US" altLang="sv-FI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1320759"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altLang="sv-FI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1320759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sv-FI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 Box 3"/>
          <p:cNvSpPr txBox="1">
            <a:spLocks noChangeArrowheads="1"/>
          </p:cNvSpPr>
          <p:nvPr/>
        </p:nvSpPr>
        <p:spPr bwMode="auto">
          <a:xfrm>
            <a:off x="4654664" y="769724"/>
            <a:ext cx="1788177" cy="48910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32080" tIns="66040" rIns="132080" bIns="66040" numCol="1" anchor="t" anchorCtr="0" compatLnSpc="1">
            <a:prstTxWarp prst="textNoShape">
              <a:avLst/>
            </a:prstTxWarp>
          </a:bodyPr>
          <a:lstStyle/>
          <a:p>
            <a:pPr defTabSz="132075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clined to participate</a:t>
            </a:r>
            <a:b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ools, n=191</a:t>
            </a:r>
            <a:endParaRPr lang="en-US" altLang="sv-FI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1320759"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alt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altLang="sv-FI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defTabSz="1320759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sv-FI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-4839208" y="623546"/>
            <a:ext cx="17610667" cy="3026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132080" tIns="66040" rIns="132080" bIns="66040" numCol="1" anchor="ctr" anchorCtr="0" compatLnSpc="1">
            <a:prstTxWarp prst="textNoShape">
              <a:avLst/>
            </a:prstTxWarp>
            <a:spAutoFit/>
          </a:bodyPr>
          <a:lstStyle/>
          <a:p>
            <a:endParaRPr lang="sv-FI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8"/>
          <p:cNvSpPr>
            <a:spLocks noChangeArrowheads="1"/>
          </p:cNvSpPr>
          <p:nvPr/>
        </p:nvSpPr>
        <p:spPr bwMode="auto">
          <a:xfrm>
            <a:off x="-4839208" y="953746"/>
            <a:ext cx="17610667" cy="3026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132080" tIns="66040" rIns="132080" bIns="66040" numCol="1" anchor="ctr" anchorCtr="0" compatLnSpc="1">
            <a:prstTxWarp prst="textNoShape">
              <a:avLst/>
            </a:prstTxWarp>
            <a:spAutoFit/>
          </a:bodyPr>
          <a:lstStyle/>
          <a:p>
            <a:endParaRPr lang="sv-FI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10"/>
          <p:cNvSpPr>
            <a:spLocks noChangeArrowheads="1"/>
          </p:cNvSpPr>
          <p:nvPr/>
        </p:nvSpPr>
        <p:spPr bwMode="auto">
          <a:xfrm>
            <a:off x="-4839208" y="953746"/>
            <a:ext cx="17610667" cy="3026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132080" tIns="66040" rIns="132080" bIns="66040" numCol="1" anchor="ctr" anchorCtr="0" compatLnSpc="1">
            <a:prstTxWarp prst="textNoShape">
              <a:avLst/>
            </a:prstTxWarp>
            <a:spAutoFit/>
          </a:bodyPr>
          <a:lstStyle/>
          <a:p>
            <a:endParaRPr lang="sv-FI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 Box 2"/>
          <p:cNvSpPr txBox="1">
            <a:spLocks noChangeArrowheads="1"/>
          </p:cNvSpPr>
          <p:nvPr/>
        </p:nvSpPr>
        <p:spPr bwMode="auto">
          <a:xfrm>
            <a:off x="2358673" y="182734"/>
            <a:ext cx="1914525" cy="43051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ACTED SCHOOLS</a:t>
            </a:r>
            <a:b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47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2" name="Text Box 2"/>
          <p:cNvSpPr txBox="1"/>
          <p:nvPr/>
        </p:nvSpPr>
        <p:spPr>
          <a:xfrm>
            <a:off x="130639" y="2855214"/>
            <a:ext cx="2108295" cy="1452762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ERVENTION GROUP</a:t>
            </a:r>
            <a:br>
              <a:rPr 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ocated to intervention group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ools, n=25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asses, n=94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1646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ys= 835 (51%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irls=804 (49%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 information=7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Text Box 2"/>
          <p:cNvSpPr txBox="1">
            <a:spLocks noChangeArrowheads="1"/>
          </p:cNvSpPr>
          <p:nvPr/>
        </p:nvSpPr>
        <p:spPr bwMode="auto">
          <a:xfrm>
            <a:off x="367878" y="4808963"/>
            <a:ext cx="1590913" cy="63556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SELINE 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1234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412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8" name="Straight Arrow Connector 37"/>
          <p:cNvCxnSpPr>
            <a:stCxn id="21" idx="2"/>
          </p:cNvCxnSpPr>
          <p:nvPr/>
        </p:nvCxnSpPr>
        <p:spPr>
          <a:xfrm flipH="1">
            <a:off x="3313670" y="613244"/>
            <a:ext cx="2266" cy="7537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 flipV="1">
            <a:off x="3329820" y="1013192"/>
            <a:ext cx="1291799" cy="215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 Box 2"/>
          <p:cNvSpPr txBox="1"/>
          <p:nvPr/>
        </p:nvSpPr>
        <p:spPr>
          <a:xfrm>
            <a:off x="2314402" y="2845829"/>
            <a:ext cx="2203810" cy="1470008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 GROUP</a:t>
            </a:r>
            <a:br>
              <a:rPr 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ocated to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roup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ools, n=24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asses, n=85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1488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ys= 727 (49,1%)</a:t>
            </a:r>
            <a:b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irls=754 (50,9%)</a:t>
            </a:r>
            <a:b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 information=7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5" name="Text Box 2"/>
          <p:cNvSpPr txBox="1"/>
          <p:nvPr/>
        </p:nvSpPr>
        <p:spPr>
          <a:xfrm>
            <a:off x="4607735" y="2855213"/>
            <a:ext cx="2183030" cy="1460623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N-TREATMENT GROUP</a:t>
            </a:r>
            <a:br>
              <a:rPr lang="sv-FI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ocated to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n-treatment group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ools, n=7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asses, n=31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385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ys= 190 (49,7%)</a:t>
            </a:r>
            <a:b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irls=192 (50,3%)</a:t>
            </a:r>
            <a:b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 information=3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6" name="Text Box 2"/>
          <p:cNvSpPr txBox="1">
            <a:spLocks noChangeArrowheads="1"/>
          </p:cNvSpPr>
          <p:nvPr/>
        </p:nvSpPr>
        <p:spPr bwMode="auto">
          <a:xfrm>
            <a:off x="2637068" y="4808962"/>
            <a:ext cx="1590913" cy="63556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SELINE 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1202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286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7" name="Text Box 2"/>
          <p:cNvSpPr txBox="1">
            <a:spLocks noChangeArrowheads="1"/>
          </p:cNvSpPr>
          <p:nvPr/>
        </p:nvSpPr>
        <p:spPr bwMode="auto">
          <a:xfrm>
            <a:off x="4906258" y="4802868"/>
            <a:ext cx="1590913" cy="63556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SELINE 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357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28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8" name="Text Box 2"/>
          <p:cNvSpPr txBox="1">
            <a:spLocks noChangeArrowheads="1"/>
          </p:cNvSpPr>
          <p:nvPr/>
        </p:nvSpPr>
        <p:spPr bwMode="auto">
          <a:xfrm>
            <a:off x="311377" y="5923861"/>
            <a:ext cx="1688039" cy="75416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D-INTERVENTION (5 weeks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1176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470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9" name="Text Box 2"/>
          <p:cNvSpPr txBox="1">
            <a:spLocks noChangeArrowheads="1"/>
          </p:cNvSpPr>
          <p:nvPr/>
        </p:nvSpPr>
        <p:spPr bwMode="auto">
          <a:xfrm>
            <a:off x="2541876" y="5929170"/>
            <a:ext cx="1619617" cy="74413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D-INTERVENTION </a:t>
            </a: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5 weeks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1112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376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0" name="Text Box 2"/>
          <p:cNvSpPr txBox="1">
            <a:spLocks noChangeArrowheads="1"/>
          </p:cNvSpPr>
          <p:nvPr/>
        </p:nvSpPr>
        <p:spPr bwMode="auto">
          <a:xfrm>
            <a:off x="4817538" y="5905220"/>
            <a:ext cx="1689546" cy="74605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D-INTERVENTION (5 weeks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0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385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1" name="Text Box 2"/>
          <p:cNvSpPr txBox="1">
            <a:spLocks noChangeArrowheads="1"/>
          </p:cNvSpPr>
          <p:nvPr/>
        </p:nvSpPr>
        <p:spPr bwMode="auto">
          <a:xfrm>
            <a:off x="253338" y="7161026"/>
            <a:ext cx="1804114" cy="79358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T-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ERVENTION (9 weeks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1180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466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2" name="Text Box 2"/>
          <p:cNvSpPr txBox="1">
            <a:spLocks noChangeArrowheads="1"/>
          </p:cNvSpPr>
          <p:nvPr/>
        </p:nvSpPr>
        <p:spPr bwMode="auto">
          <a:xfrm>
            <a:off x="2510425" y="7156785"/>
            <a:ext cx="1744382" cy="77287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T-INTERVENTION (9 weeks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1125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363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3" name="Text Box 2"/>
          <p:cNvSpPr txBox="1">
            <a:spLocks noChangeArrowheads="1"/>
          </p:cNvSpPr>
          <p:nvPr/>
        </p:nvSpPr>
        <p:spPr bwMode="auto">
          <a:xfrm>
            <a:off x="4815829" y="7156785"/>
            <a:ext cx="1762225" cy="76435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T-INTERVENTION (9 weeks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324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61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4" name="Text Box 2"/>
          <p:cNvSpPr txBox="1">
            <a:spLocks noChangeArrowheads="1"/>
          </p:cNvSpPr>
          <p:nvPr/>
        </p:nvSpPr>
        <p:spPr bwMode="auto">
          <a:xfrm>
            <a:off x="259682" y="8443077"/>
            <a:ext cx="1850207" cy="75918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LLOW-UP </a:t>
            </a:r>
            <a:b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26 weeks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971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675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6" name="Text Box 2"/>
          <p:cNvSpPr txBox="1">
            <a:spLocks noChangeArrowheads="1"/>
          </p:cNvSpPr>
          <p:nvPr/>
        </p:nvSpPr>
        <p:spPr bwMode="auto">
          <a:xfrm>
            <a:off x="2541876" y="8443077"/>
            <a:ext cx="1748862" cy="75673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LLOW-UP </a:t>
            </a:r>
            <a:b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26 weeks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1039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449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7" name="Text Box 2"/>
          <p:cNvSpPr txBox="1">
            <a:spLocks noChangeArrowheads="1"/>
          </p:cNvSpPr>
          <p:nvPr/>
        </p:nvSpPr>
        <p:spPr bwMode="auto">
          <a:xfrm>
            <a:off x="4799189" y="8447017"/>
            <a:ext cx="1707895" cy="75279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LLOW-UP</a:t>
            </a:r>
            <a:b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26 weeks)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s, n=308</a:t>
            </a:r>
            <a:b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op-out, n=77</a:t>
            </a:r>
            <a:endParaRPr lang="sv-FI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70" name="Straight Arrow Connector 69"/>
          <p:cNvCxnSpPr>
            <a:stCxn id="2" idx="2"/>
          </p:cNvCxnSpPr>
          <p:nvPr/>
        </p:nvCxnSpPr>
        <p:spPr>
          <a:xfrm flipH="1">
            <a:off x="3329819" y="2341179"/>
            <a:ext cx="2" cy="473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1155519" y="2574699"/>
            <a:ext cx="4506792" cy="11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/>
          <p:nvPr/>
        </p:nvCxnSpPr>
        <p:spPr>
          <a:xfrm>
            <a:off x="1155519" y="2574699"/>
            <a:ext cx="0" cy="2585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>
            <a:off x="5654485" y="2574699"/>
            <a:ext cx="0" cy="2585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>
            <a:off x="1155516" y="4371292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3323374" y="4371292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>
            <a:off x="5656687" y="4361276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1163335" y="5489480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>
            <a:off x="3329819" y="5475453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5666731" y="5465938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>
            <a:off x="1163333" y="6722971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/>
          <p:nvPr/>
        </p:nvCxnSpPr>
        <p:spPr>
          <a:xfrm>
            <a:off x="3323373" y="6722970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>
            <a:off x="5696942" y="6709986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>
            <a:off x="1155394" y="8042043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/>
          <p:nvPr/>
        </p:nvCxnSpPr>
        <p:spPr>
          <a:xfrm>
            <a:off x="3323372" y="8023712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>
            <a:off x="5696940" y="8022977"/>
            <a:ext cx="1" cy="3894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9631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1</TotalTime>
  <Words>370</Words>
  <Application>Microsoft Macintosh PowerPoint</Application>
  <PresentationFormat>A4 Paper (210x297 mm)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LIGIBLE SCHOOLS n=247</dc:title>
  <dc:creator>Emilia Keijonen</dc:creator>
  <cp:lastModifiedBy>Maarit Lassander</cp:lastModifiedBy>
  <cp:revision>39</cp:revision>
  <cp:lastPrinted>2017-06-16T07:50:33Z</cp:lastPrinted>
  <dcterms:created xsi:type="dcterms:W3CDTF">2017-06-12T06:41:44Z</dcterms:created>
  <dcterms:modified xsi:type="dcterms:W3CDTF">2021-01-27T10:54:15Z</dcterms:modified>
</cp:coreProperties>
</file>